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7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A0065"/>
    <a:srgbClr val="003969"/>
    <a:srgbClr val="65AA00"/>
    <a:srgbClr val="0092F7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8077" autoAdjust="0"/>
    <p:restoredTop sz="94660"/>
  </p:normalViewPr>
  <p:slideViewPr>
    <p:cSldViewPr snapToGrid="0">
      <p:cViewPr varScale="1">
        <p:scale>
          <a:sx n="80" d="100"/>
          <a:sy n="80" d="100"/>
        </p:scale>
        <p:origin x="1286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6/02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948A3A-29D4-44D6-0EB0-CE2B69BB640B}"/>
              </a:ext>
            </a:extLst>
          </p:cNvPr>
          <p:cNvSpPr txBox="1">
            <a:spLocks/>
          </p:cNvSpPr>
          <p:nvPr/>
        </p:nvSpPr>
        <p:spPr>
          <a:xfrm>
            <a:off x="152400" y="0"/>
            <a:ext cx="10052685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>
              <a:lnSpc>
                <a:spcPct val="100000"/>
              </a:lnSpc>
            </a:pPr>
            <a:r>
              <a:rPr lang="en-US" sz="2800" b="1" dirty="0">
                <a:solidFill>
                  <a:schemeClr val="bg1"/>
                </a:solidFill>
                <a:effectLst/>
                <a:ea typeface="Arial" panose="020B0604020202020204" pitchFamily="34" charset="0"/>
              </a:rPr>
              <a:t>Non-infectious complications of peritoneal dialysis in children </a:t>
            </a:r>
            <a:endParaRPr lang="it-IT" sz="2800" b="1" dirty="0">
              <a:solidFill>
                <a:schemeClr val="bg1"/>
              </a:solidFill>
              <a:effectLst/>
              <a:ea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98172A3-B575-316A-64DF-267B75C4D920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Parolin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F681059-5890-5822-ECFE-A91B61BC57D3}"/>
              </a:ext>
            </a:extLst>
          </p:cNvPr>
          <p:cNvSpPr txBox="1"/>
          <p:nvPr/>
        </p:nvSpPr>
        <p:spPr>
          <a:xfrm>
            <a:off x="87819" y="5842889"/>
            <a:ext cx="728462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TAKE HOME MESSAGE</a:t>
            </a:r>
            <a:r>
              <a:rPr lang="en-GB" dirty="0">
                <a:solidFill>
                  <a:schemeClr val="bg1"/>
                </a:solidFill>
              </a:rPr>
              <a:t>: Non-infectious complications of </a:t>
            </a:r>
            <a:r>
              <a:rPr lang="en-GB" dirty="0" err="1">
                <a:solidFill>
                  <a:schemeClr val="bg1"/>
                </a:solidFill>
              </a:rPr>
              <a:t>pediatric</a:t>
            </a:r>
            <a:r>
              <a:rPr lang="en-GB" dirty="0">
                <a:solidFill>
                  <a:schemeClr val="bg1"/>
                </a:solidFill>
              </a:rPr>
              <a:t> peritoneal dialysis pose ongoing challenges. Innovative strategies to preserve membrane function and optimize care are essential to improve outcomes.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CCBD21B-2D76-A9F5-ECF6-56BF9ABDA480}"/>
              </a:ext>
            </a:extLst>
          </p:cNvPr>
          <p:cNvSpPr txBox="1"/>
          <p:nvPr/>
        </p:nvSpPr>
        <p:spPr>
          <a:xfrm>
            <a:off x="437700" y="1257572"/>
            <a:ext cx="5780279" cy="38003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1200"/>
              </a:spcAft>
            </a:pPr>
            <a:r>
              <a:rPr lang="en-GB" b="1" dirty="0">
                <a:solidFill>
                  <a:srgbClr val="003969"/>
                </a:solidFill>
              </a:rPr>
              <a:t>Key points</a:t>
            </a:r>
            <a:r>
              <a:rPr lang="en-GB" dirty="0">
                <a:solidFill>
                  <a:srgbClr val="003969"/>
                </a:solidFill>
              </a:rPr>
              <a:t>: </a:t>
            </a:r>
          </a:p>
          <a:p>
            <a:pPr marL="342900" lvl="0" indent="-342900">
              <a:lnSpc>
                <a:spcPct val="120000"/>
              </a:lnSpc>
              <a:spcAft>
                <a:spcPts val="1200"/>
              </a:spcAft>
              <a:buFont typeface="+mj-lt"/>
              <a:buAutoNum type="arabicPeriod"/>
            </a:pPr>
            <a:r>
              <a:rPr lang="en-US" dirty="0">
                <a:solidFill>
                  <a:srgbClr val="003969"/>
                </a:solidFill>
                <a:effectLst/>
                <a:ea typeface="Arial" panose="020B0604020202020204" pitchFamily="34" charset="0"/>
              </a:rPr>
              <a:t>Catheter-related issues remain a common challenge, affecting dialysis efficiency and patient comfort.</a:t>
            </a:r>
            <a:endParaRPr lang="it-IT" dirty="0">
              <a:solidFill>
                <a:srgbClr val="003969"/>
              </a:solidFill>
              <a:effectLst/>
              <a:ea typeface="Times New Roman" panose="02020603050405020304" pitchFamily="18" charset="0"/>
            </a:endParaRPr>
          </a:p>
          <a:p>
            <a:pPr marL="342900" lvl="0" indent="-342900">
              <a:lnSpc>
                <a:spcPct val="120000"/>
              </a:lnSpc>
              <a:spcAft>
                <a:spcPts val="1200"/>
              </a:spcAft>
              <a:buFont typeface="+mj-lt"/>
              <a:buAutoNum type="arabicPeriod"/>
            </a:pPr>
            <a:r>
              <a:rPr lang="en-US" dirty="0">
                <a:solidFill>
                  <a:srgbClr val="003969"/>
                </a:solidFill>
                <a:effectLst/>
                <a:ea typeface="Arial" panose="020B0604020202020204" pitchFamily="34" charset="0"/>
              </a:rPr>
              <a:t>Peritoneal membrane failure, driven by prolonged PD and glucose-associated toxicity, often leads to ultrafiltration failure and can progress to encapsulating peritoneal sclerosis.</a:t>
            </a:r>
            <a:endParaRPr lang="it-IT" dirty="0">
              <a:solidFill>
                <a:srgbClr val="003969"/>
              </a:solidFill>
              <a:effectLst/>
              <a:ea typeface="Times New Roman" panose="02020603050405020304" pitchFamily="18" charset="0"/>
            </a:endParaRPr>
          </a:p>
          <a:p>
            <a:pPr marL="342900" lvl="0" indent="-342900">
              <a:lnSpc>
                <a:spcPct val="120000"/>
              </a:lnSpc>
              <a:spcAft>
                <a:spcPts val="600"/>
              </a:spcAft>
              <a:buFont typeface="+mj-lt"/>
              <a:buAutoNum type="arabicPeriod"/>
            </a:pPr>
            <a:r>
              <a:rPr lang="en-US" dirty="0">
                <a:solidFill>
                  <a:srgbClr val="003969"/>
                </a:solidFill>
                <a:effectLst/>
                <a:ea typeface="Arial" panose="020B0604020202020204" pitchFamily="34" charset="0"/>
              </a:rPr>
              <a:t>Ongoing research and advancements in treatment strategies are essential to minimizing these complications and improving patient outcomes.</a:t>
            </a:r>
            <a:endParaRPr lang="it-IT" dirty="0">
              <a:solidFill>
                <a:srgbClr val="003969"/>
              </a:solidFill>
              <a:effectLst/>
              <a:ea typeface="Times New Roman" panose="02020603050405020304" pitchFamily="18" charset="0"/>
            </a:endParaRPr>
          </a:p>
        </p:txBody>
      </p:sp>
      <p:graphicFrame>
        <p:nvGraphicFramePr>
          <p:cNvPr id="3" name="Tabella 2">
            <a:extLst>
              <a:ext uri="{FF2B5EF4-FFF2-40B4-BE49-F238E27FC236}">
                <a16:creationId xmlns:a16="http://schemas.microsoft.com/office/drawing/2014/main" id="{ADDA6A27-DA74-BC84-225B-AF158076D9E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61115597"/>
              </p:ext>
            </p:extLst>
          </p:nvPr>
        </p:nvGraphicFramePr>
        <p:xfrm>
          <a:off x="6580002" y="1248045"/>
          <a:ext cx="5440546" cy="4247876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1234609">
                  <a:extLst>
                    <a:ext uri="{9D8B030D-6E8A-4147-A177-3AD203B41FA5}">
                      <a16:colId xmlns:a16="http://schemas.microsoft.com/office/drawing/2014/main" val="2531727595"/>
                    </a:ext>
                  </a:extLst>
                </a:gridCol>
                <a:gridCol w="2102678">
                  <a:extLst>
                    <a:ext uri="{9D8B030D-6E8A-4147-A177-3AD203B41FA5}">
                      <a16:colId xmlns:a16="http://schemas.microsoft.com/office/drawing/2014/main" val="1285338233"/>
                    </a:ext>
                  </a:extLst>
                </a:gridCol>
                <a:gridCol w="2103259">
                  <a:extLst>
                    <a:ext uri="{9D8B030D-6E8A-4147-A177-3AD203B41FA5}">
                      <a16:colId xmlns:a16="http://schemas.microsoft.com/office/drawing/2014/main" val="2876786631"/>
                    </a:ext>
                  </a:extLst>
                </a:gridCol>
              </a:tblGrid>
              <a:tr h="221369"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solidFill>
                            <a:schemeClr val="bg1"/>
                          </a:solidFill>
                          <a:effectLst/>
                        </a:rPr>
                        <a:t>Complication</a:t>
                      </a:r>
                      <a:endParaRPr lang="it-IT" sz="900" b="1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5239" marR="4523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3969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solidFill>
                            <a:schemeClr val="bg1"/>
                          </a:solidFill>
                          <a:effectLst/>
                        </a:rPr>
                        <a:t>Description</a:t>
                      </a:r>
                      <a:endParaRPr lang="it-IT" sz="900" b="1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5239" marR="45239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3969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solidFill>
                            <a:schemeClr val="bg1"/>
                          </a:solidFill>
                          <a:effectLst/>
                        </a:rPr>
                        <a:t>Risk Factors</a:t>
                      </a:r>
                      <a:endParaRPr lang="it-IT" sz="900" b="1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5239" marR="45239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396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53901305"/>
                  </a:ext>
                </a:extLst>
              </a:tr>
              <a:tr h="194714">
                <a:tc gridSpan="3"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solidFill>
                            <a:schemeClr val="bg1"/>
                          </a:solidFill>
                          <a:effectLst/>
                        </a:rPr>
                        <a:t>Mechanical complications</a:t>
                      </a:r>
                      <a:endParaRPr lang="it-IT" sz="900" b="1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5239" marR="4523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A0065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60337901"/>
                  </a:ext>
                </a:extLst>
              </a:tr>
              <a:tr h="309809">
                <a:tc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</a:rPr>
                        <a:t>PD Fluid Flow Obstruction</a:t>
                      </a:r>
                      <a:endParaRPr lang="it-IT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</a:rPr>
                        <a:t>Blockage of PD fluid inflow and/or outflow</a:t>
                      </a:r>
                      <a:endParaRPr lang="it-IT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</a:rPr>
                        <a:t>Age &gt;1 year, weight &gt;10 kg (for early obstructions), young age for dislocation, catheter migration.</a:t>
                      </a:r>
                      <a:endParaRPr lang="it-IT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2175316"/>
                  </a:ext>
                </a:extLst>
              </a:tr>
              <a:tr h="309809">
                <a:tc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</a:rPr>
                        <a:t>Fluid Leakage</a:t>
                      </a:r>
                      <a:endParaRPr lang="it-IT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</a:rPr>
                        <a:t>Leakage of PD fluid from the catheter exit-site or other routes.</a:t>
                      </a:r>
                      <a:endParaRPr lang="it-IT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</a:rPr>
                        <a:t>High intra-abdominal pressure, abdominal weakness.</a:t>
                      </a:r>
                      <a:endParaRPr lang="it-IT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77255532"/>
                  </a:ext>
                </a:extLst>
              </a:tr>
              <a:tr h="309809">
                <a:tc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</a:rPr>
                        <a:t>Hernia</a:t>
                      </a:r>
                      <a:endParaRPr lang="it-IT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</a:rPr>
                        <a:t>Abdominal wall hernias from elevated intra-abdominal pressure.</a:t>
                      </a:r>
                      <a:endParaRPr lang="it-IT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</a:rPr>
                        <a:t>Abdominal wall weakness, prior surgery.</a:t>
                      </a:r>
                      <a:endParaRPr lang="it-IT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35618293"/>
                  </a:ext>
                </a:extLst>
              </a:tr>
              <a:tr h="309809">
                <a:tc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</a:rPr>
                        <a:t>Pleuro-Peritoneal Leaks</a:t>
                      </a:r>
                      <a:endParaRPr lang="it-IT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</a:rPr>
                        <a:t>Migration of PD fluid to pleural/pericardial cavities due to diaphragmatic defects.</a:t>
                      </a:r>
                      <a:endParaRPr lang="it-IT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</a:rPr>
                        <a:t>Low albumin, diaphragmatic defects, young age, thoracic surgery</a:t>
                      </a:r>
                      <a:endParaRPr lang="it-IT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15246535"/>
                  </a:ext>
                </a:extLst>
              </a:tr>
              <a:tr h="309809">
                <a:tc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</a:rPr>
                        <a:t>Ventilation Problems</a:t>
                      </a:r>
                      <a:endParaRPr lang="it-IT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</a:rPr>
                        <a:t>Respiratory issues due to intra-abdominal pressure during PD.</a:t>
                      </a:r>
                      <a:endParaRPr lang="it-IT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</a:rPr>
                        <a:t>Respiratory insufficiency, mechanical ventilation.</a:t>
                      </a:r>
                      <a:endParaRPr lang="it-IT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36000" marR="3600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66982535"/>
                  </a:ext>
                </a:extLst>
              </a:tr>
              <a:tr h="194714">
                <a:tc gridSpan="3"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solidFill>
                            <a:schemeClr val="bg1"/>
                          </a:solidFill>
                          <a:effectLst/>
                        </a:rPr>
                        <a:t>Technique-related complications</a:t>
                      </a:r>
                      <a:endParaRPr lang="it-IT" sz="900" b="1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5239" marR="4523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A0065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71037156"/>
                  </a:ext>
                </a:extLst>
              </a:tr>
              <a:tr h="309809">
                <a:tc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</a:rPr>
                        <a:t>Membrane Failure </a:t>
                      </a:r>
                      <a:endParaRPr lang="it-IT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5239" marR="4523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</a:rPr>
                        <a:t>Loss of peritoneal membrane function, leading to impaired ultrafiltration and clearance</a:t>
                      </a:r>
                      <a:endParaRPr lang="it-IT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5239" marR="45239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</a:rPr>
                        <a:t>Prolonged PD, recurrent peritonitis, high glucose load.</a:t>
                      </a:r>
                      <a:endParaRPr lang="it-IT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5239" marR="45239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96202921"/>
                  </a:ext>
                </a:extLst>
              </a:tr>
              <a:tr h="309809">
                <a:tc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</a:rPr>
                        <a:t>Encapsulated Peritoneal Sclerosis </a:t>
                      </a:r>
                      <a:endParaRPr lang="it-IT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5239" marR="4523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</a:rPr>
                        <a:t>Progressive fibrotic process encasing bowel loops, causing peritoneal sclerosis.</a:t>
                      </a:r>
                      <a:endParaRPr lang="it-IT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5239" marR="45239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</a:rPr>
                        <a:t>Long PD duration, recurrent peritonitis, genetic factors, pro-fibrotic drugs</a:t>
                      </a:r>
                      <a:endParaRPr lang="it-IT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5239" marR="45239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86359574"/>
                  </a:ext>
                </a:extLst>
              </a:tr>
              <a:tr h="194714">
                <a:tc gridSpan="3"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solidFill>
                            <a:schemeClr val="bg1"/>
                          </a:solidFill>
                          <a:effectLst/>
                        </a:rPr>
                        <a:t>Other complications</a:t>
                      </a:r>
                      <a:endParaRPr lang="it-IT" sz="900" b="1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5239" marR="4523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AA0065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27390662"/>
                  </a:ext>
                </a:extLst>
              </a:tr>
              <a:tr h="309809">
                <a:tc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</a:rPr>
                        <a:t>Pancreatitis</a:t>
                      </a:r>
                      <a:endParaRPr lang="it-IT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5239" marR="4523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</a:rPr>
                        <a:t>Inflammation of the pancreas</a:t>
                      </a:r>
                      <a:endParaRPr lang="it-IT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5239" marR="45239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</a:rPr>
                        <a:t>Hypercalcemia, hyperglycemia, </a:t>
                      </a:r>
                      <a:r>
                        <a:rPr lang="en-US" sz="700" dirty="0" err="1">
                          <a:effectLst/>
                        </a:rPr>
                        <a:t>pancreatotoxic</a:t>
                      </a:r>
                      <a:r>
                        <a:rPr lang="en-US" sz="700" dirty="0">
                          <a:effectLst/>
                        </a:rPr>
                        <a:t> drugs.</a:t>
                      </a:r>
                      <a:endParaRPr lang="it-IT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5239" marR="45239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98269202"/>
                  </a:ext>
                </a:extLst>
              </a:tr>
              <a:tr h="309809">
                <a:tc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</a:rPr>
                        <a:t>Hemoperitoneum</a:t>
                      </a:r>
                      <a:endParaRPr lang="it-IT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5239" marR="4523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</a:rPr>
                        <a:t>Presence of blood in the peritoneal cavity, causing abdominal pain and potential shock.</a:t>
                      </a:r>
                      <a:endParaRPr lang="it-IT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5239" marR="45239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</a:rPr>
                        <a:t>Catheter-related trauma, menstruation, coagulation disorders.</a:t>
                      </a:r>
                      <a:endParaRPr lang="it-IT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5239" marR="45239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69172086"/>
                  </a:ext>
                </a:extLst>
              </a:tr>
              <a:tr h="309809">
                <a:tc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</a:rPr>
                        <a:t>Ischemic Colitis and Necrotizing Enterocolitis</a:t>
                      </a:r>
                      <a:endParaRPr lang="it-IT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5239" marR="4523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</a:rPr>
                        <a:t>Bowel damage due to reduced blood flow, leading to inflammation and infection.</a:t>
                      </a:r>
                      <a:endParaRPr lang="it-IT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5239" marR="45239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</a:rPr>
                        <a:t>Vascular compromise, intraperitoneal inflammation.</a:t>
                      </a:r>
                      <a:endParaRPr lang="it-IT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45239" marR="45239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89805888"/>
                  </a:ext>
                </a:extLst>
              </a:tr>
              <a:tr h="344275">
                <a:tc>
                  <a:txBody>
                    <a:bodyPr/>
                    <a:lstStyle/>
                    <a:p>
                      <a:r>
                        <a:rPr lang="it-IT" sz="700" dirty="0" err="1">
                          <a:effectLst/>
                          <a:latin typeface="+mn-lt"/>
                          <a:ea typeface="Times New Roman" panose="02020603050405020304" pitchFamily="18" charset="0"/>
                        </a:rPr>
                        <a:t>Electrolyte</a:t>
                      </a:r>
                      <a:r>
                        <a:rPr lang="it-IT" sz="700" dirty="0">
                          <a:effectLst/>
                          <a:latin typeface="+mn-lt"/>
                          <a:ea typeface="Times New Roman" panose="02020603050405020304" pitchFamily="18" charset="0"/>
                        </a:rPr>
                        <a:t> and Volume Balance Disorders</a:t>
                      </a:r>
                    </a:p>
                  </a:txBody>
                  <a:tcPr marL="45239" marR="4523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700" dirty="0">
                          <a:effectLst/>
                          <a:latin typeface="+mn-lt"/>
                          <a:ea typeface="Times New Roman" panose="02020603050405020304" pitchFamily="18" charset="0"/>
                        </a:rPr>
                        <a:t>PD can be </a:t>
                      </a:r>
                      <a:r>
                        <a:rPr lang="it-IT" sz="700" dirty="0" err="1">
                          <a:effectLst/>
                          <a:latin typeface="+mn-lt"/>
                          <a:ea typeface="Times New Roman" panose="02020603050405020304" pitchFamily="18" charset="0"/>
                        </a:rPr>
                        <a:t>associated</a:t>
                      </a:r>
                      <a:r>
                        <a:rPr lang="it-IT" sz="700" dirty="0">
                          <a:effectLst/>
                          <a:latin typeface="+mn-lt"/>
                          <a:ea typeface="Times New Roman" panose="02020603050405020304" pitchFamily="18" charset="0"/>
                        </a:rPr>
                        <a:t> with </a:t>
                      </a:r>
                      <a:r>
                        <a:rPr lang="it-IT" sz="700" dirty="0" err="1">
                          <a:effectLst/>
                          <a:latin typeface="+mn-lt"/>
                          <a:ea typeface="Times New Roman" panose="02020603050405020304" pitchFamily="18" charset="0"/>
                        </a:rPr>
                        <a:t>fluid</a:t>
                      </a:r>
                      <a:r>
                        <a:rPr lang="it-IT" sz="700" dirty="0">
                          <a:effectLst/>
                          <a:latin typeface="+mn-lt"/>
                          <a:ea typeface="Times New Roman" panose="02020603050405020304" pitchFamily="18" charset="0"/>
                        </a:rPr>
                        <a:t> </a:t>
                      </a:r>
                      <a:r>
                        <a:rPr lang="it-IT" sz="700" dirty="0" err="1">
                          <a:effectLst/>
                          <a:latin typeface="+mn-lt"/>
                          <a:ea typeface="Times New Roman" panose="02020603050405020304" pitchFamily="18" charset="0"/>
                        </a:rPr>
                        <a:t>overload</a:t>
                      </a:r>
                      <a:r>
                        <a:rPr lang="it-IT" sz="700" dirty="0">
                          <a:effectLst/>
                          <a:latin typeface="+mn-lt"/>
                          <a:ea typeface="Times New Roman" panose="02020603050405020304" pitchFamily="18" charset="0"/>
                        </a:rPr>
                        <a:t>, </a:t>
                      </a:r>
                      <a:r>
                        <a:rPr lang="it-IT" sz="700" dirty="0" err="1">
                          <a:effectLst/>
                          <a:latin typeface="+mn-lt"/>
                          <a:ea typeface="Times New Roman" panose="02020603050405020304" pitchFamily="18" charset="0"/>
                        </a:rPr>
                        <a:t>electrolyte</a:t>
                      </a:r>
                      <a:r>
                        <a:rPr lang="it-IT" sz="700" dirty="0">
                          <a:effectLst/>
                          <a:latin typeface="+mn-lt"/>
                          <a:ea typeface="Times New Roman" panose="02020603050405020304" pitchFamily="18" charset="0"/>
                        </a:rPr>
                        <a:t> </a:t>
                      </a:r>
                      <a:r>
                        <a:rPr lang="it-IT" sz="700" dirty="0" err="1">
                          <a:effectLst/>
                          <a:latin typeface="+mn-lt"/>
                          <a:ea typeface="Times New Roman" panose="02020603050405020304" pitchFamily="18" charset="0"/>
                        </a:rPr>
                        <a:t>imbalance</a:t>
                      </a:r>
                      <a:r>
                        <a:rPr lang="it-IT" sz="700" dirty="0">
                          <a:effectLst/>
                          <a:latin typeface="+mn-lt"/>
                          <a:ea typeface="Times New Roman" panose="02020603050405020304" pitchFamily="18" charset="0"/>
                        </a:rPr>
                        <a:t>, </a:t>
                      </a:r>
                      <a:r>
                        <a:rPr lang="it-IT" sz="700" dirty="0" err="1">
                          <a:effectLst/>
                          <a:latin typeface="+mn-lt"/>
                          <a:ea typeface="Times New Roman" panose="02020603050405020304" pitchFamily="18" charset="0"/>
                        </a:rPr>
                        <a:t>vascular</a:t>
                      </a:r>
                      <a:r>
                        <a:rPr lang="it-IT" sz="700" dirty="0">
                          <a:effectLst/>
                          <a:latin typeface="+mn-lt"/>
                          <a:ea typeface="Times New Roman" panose="02020603050405020304" pitchFamily="18" charset="0"/>
                        </a:rPr>
                        <a:t> events, and rare </a:t>
                      </a:r>
                      <a:r>
                        <a:rPr lang="it-IT" sz="700" dirty="0" err="1">
                          <a:effectLst/>
                          <a:latin typeface="+mn-lt"/>
                          <a:ea typeface="Times New Roman" panose="02020603050405020304" pitchFamily="18" charset="0"/>
                        </a:rPr>
                        <a:t>hypotension-induced</a:t>
                      </a:r>
                      <a:r>
                        <a:rPr lang="it-IT" sz="700" dirty="0">
                          <a:effectLst/>
                          <a:latin typeface="+mn-lt"/>
                          <a:ea typeface="Times New Roman" panose="02020603050405020304" pitchFamily="18" charset="0"/>
                        </a:rPr>
                        <a:t> </a:t>
                      </a:r>
                      <a:r>
                        <a:rPr lang="it-IT" sz="700" dirty="0" err="1">
                          <a:effectLst/>
                          <a:latin typeface="+mn-lt"/>
                          <a:ea typeface="Times New Roman" panose="02020603050405020304" pitchFamily="18" charset="0"/>
                        </a:rPr>
                        <a:t>blindness</a:t>
                      </a:r>
                      <a:endParaRPr lang="it-IT" sz="700" dirty="0">
                        <a:effectLst/>
                        <a:latin typeface="+mn-lt"/>
                        <a:ea typeface="Times New Roman" panose="02020603050405020304" pitchFamily="18" charset="0"/>
                      </a:endParaRPr>
                    </a:p>
                  </a:txBody>
                  <a:tcPr marL="45239" marR="45239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it-IT" sz="700" dirty="0">
                          <a:effectLst/>
                          <a:latin typeface="+mn-lt"/>
                          <a:ea typeface="Times New Roman" panose="02020603050405020304" pitchFamily="18" charset="0"/>
                        </a:rPr>
                        <a:t>Loss of residual diuresis, sodium and potassium sieving, chronic or acute hypotension, fluid depletion</a:t>
                      </a:r>
                    </a:p>
                  </a:txBody>
                  <a:tcPr marL="45239" marR="45239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1234569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778072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378</Words>
  <Application>Microsoft Office PowerPoint</Application>
  <PresentationFormat>Widescreen</PresentationFormat>
  <Paragraphs>4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0</cp:revision>
  <dcterms:created xsi:type="dcterms:W3CDTF">2019-06-13T12:30:18Z</dcterms:created>
  <dcterms:modified xsi:type="dcterms:W3CDTF">2025-02-06T14:55:35Z</dcterms:modified>
</cp:coreProperties>
</file>